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media/image1.jpeg" ContentType="image/jpeg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080625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680328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77640" y="5412600"/>
            <a:ext cx="680328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863880" y="235872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77640" y="541260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863880" y="541260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219024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677680" y="2358720"/>
            <a:ext cx="219024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978080" y="2358720"/>
            <a:ext cx="219024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77640" y="5412600"/>
            <a:ext cx="219024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677680" y="5412600"/>
            <a:ext cx="219024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978080" y="5412600"/>
            <a:ext cx="219024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77640" y="2358720"/>
            <a:ext cx="6803280" cy="58464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6803280" cy="5846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3319920" cy="5846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863880" y="2358720"/>
            <a:ext cx="3319920" cy="5846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77640" y="402120"/>
            <a:ext cx="6803280" cy="7802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863880" y="2358720"/>
            <a:ext cx="3319920" cy="5846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77640" y="541260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3319920" cy="5846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863880" y="235872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863880" y="541260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863880" y="2358720"/>
            <a:ext cx="331992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77640" y="5412600"/>
            <a:ext cx="6803280" cy="278856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7640" y="402120"/>
            <a:ext cx="680328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fr-FR" sz="4400" spc="-1" strike="noStrike">
                <a:latin typeface="Arial"/>
              </a:rPr>
              <a:t>Click to edit the title text format</a:t>
            </a:r>
            <a:endParaRPr b="0" lang="fr-FR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7640" y="2358720"/>
            <a:ext cx="6803280" cy="58464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3200" spc="-1" strike="noStrike">
                <a:latin typeface="Arial"/>
              </a:rPr>
              <a:t>Click to edit the outline text format</a:t>
            </a:r>
            <a:endParaRPr b="0" lang="fr-FR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800" spc="-1" strike="noStrike">
                <a:latin typeface="Arial"/>
              </a:rPr>
              <a:t>Second Outline Level</a:t>
            </a:r>
            <a:endParaRPr b="0" lang="fr-FR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400" spc="-1" strike="noStrike">
                <a:latin typeface="Arial"/>
              </a:rPr>
              <a:t>Third Outline Level</a:t>
            </a:r>
            <a:endParaRPr b="0" lang="fr-FR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latin typeface="Arial"/>
              </a:rPr>
              <a:t>Fourth Outline Level</a:t>
            </a:r>
            <a:endParaRPr b="0" lang="fr-FR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latin typeface="Arial"/>
              </a:rPr>
              <a:t>Fifth Outline Level</a:t>
            </a:r>
            <a:endParaRPr b="0" lang="fr-FR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latin typeface="Arial"/>
              </a:rPr>
              <a:t>Sixth Outline Level</a:t>
            </a:r>
            <a:endParaRPr b="0" lang="fr-FR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latin typeface="Arial"/>
              </a:rPr>
              <a:t>Seventh Outline Level</a:t>
            </a:r>
            <a:endParaRPr b="0" lang="fr-FR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1"/>
          <p:cNvGrpSpPr/>
          <p:nvPr/>
        </p:nvGrpSpPr>
        <p:grpSpPr>
          <a:xfrm>
            <a:off x="864000" y="1656000"/>
            <a:ext cx="6047280" cy="6224400"/>
            <a:chOff x="864000" y="1656000"/>
            <a:chExt cx="6047280" cy="6224400"/>
          </a:xfrm>
        </p:grpSpPr>
        <p:sp>
          <p:nvSpPr>
            <p:cNvPr id="39" name="CustomShape 2"/>
            <p:cNvSpPr/>
            <p:nvPr/>
          </p:nvSpPr>
          <p:spPr>
            <a:xfrm>
              <a:off x="864000" y="7029360"/>
              <a:ext cx="6047280" cy="8510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just">
                <a:lnSpc>
                  <a:spcPct val="100000"/>
                </a:lnSpc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Droid Sans Fallback"/>
                </a:rPr>
                <a:t>Supplemental Figure 1: Alignement of NADP-ICDH sequence </a:t>
              </a: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from different eukaryotics.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Droid Sans Fallback"/>
                </a:rPr>
                <a:t>Conserved amino acids with most plant and mammalian NADP-ICDH proteins,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 involved in the active site pocket [34], are indicated in red. Conserved Cysteines are shown in yellow and Cys363 is indicated with an arrowhead. Amino acids are numbered from the sequence of the AtICDH-NADPmito/chloro.</a:t>
              </a:r>
              <a:endParaRPr b="0" lang="fr-FR" sz="1000" spc="-1" strike="noStrike">
                <a:latin typeface="Arial"/>
              </a:endParaRPr>
            </a:p>
            <a:p>
              <a:pPr algn="just">
                <a:lnSpc>
                  <a:spcPct val="100000"/>
                </a:lnSpc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t, Arabidopsis thaliana ; Os, Oryza sativa ; Pt, Populus trichocarpa ; Rc, Ricinus communis ; Mt, Medicago truncatula ; Hs, Homo sapiens ; Bt, Bos taurus ; Cl, Canis lupus; Dr, Danio rerio.</a:t>
              </a:r>
              <a:endParaRPr b="0" lang="fr-FR" sz="1000" spc="-1" strike="noStrike">
                <a:latin typeface="Arial"/>
              </a:endParaRPr>
            </a:p>
            <a:p>
              <a:pPr algn="just">
                <a:lnSpc>
                  <a:spcPct val="100000"/>
                </a:lnSpc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tICDH-NADPcyto, At1g65930 ; AtICDH-NADPmito/chloro, At5g14590 ; AtICDH-NADPperox, At1g54340 ; OsNADP-ICDHcyto, NP_001043749 ; OsNADP-ICDHmito, NP_001053269 ; PtNADP-ICDHcyto, XP_006372414 ; RcNADP-ICDHcyto, XP_002528517 ; MtNADP-ICDHcyto, XP_003616186 ; HsICDH-NADPcyto, AAD02918 ; HsNADP-ICDHmito, BAD96636 ; BtNADP-ICDHcyto, NP_786984 ; ClNADP-ICDHcyto, XP_536047 ; DrNADP-ICDHcyto, XP_005167712.</a:t>
              </a:r>
              <a:endParaRPr b="0" lang="fr-FR" sz="1000" spc="-1" strike="noStrike">
                <a:latin typeface="Arial"/>
              </a:endParaRPr>
            </a:p>
            <a:p>
              <a:pPr algn="just">
                <a:lnSpc>
                  <a:spcPct val="100000"/>
                </a:lnSpc>
              </a:pPr>
              <a:endParaRPr b="0" lang="fr-FR" sz="1000" spc="-1" strike="noStrike">
                <a:latin typeface="Arial"/>
              </a:endParaRPr>
            </a:p>
          </p:txBody>
        </p:sp>
        <p:pic>
          <p:nvPicPr>
            <p:cNvPr id="40" name="" descr=""/>
            <p:cNvPicPr/>
            <p:nvPr/>
          </p:nvPicPr>
          <p:blipFill>
            <a:blip r:embed="rId1"/>
            <a:stretch/>
          </p:blipFill>
          <p:spPr>
            <a:xfrm>
              <a:off x="936000" y="1656000"/>
              <a:ext cx="5686920" cy="4581720"/>
            </a:xfrm>
            <a:prstGeom prst="rect">
              <a:avLst/>
            </a:prstGeom>
            <a:ln>
              <a:noFill/>
            </a:ln>
          </p:spPr>
        </p:pic>
        <p:sp>
          <p:nvSpPr>
            <p:cNvPr id="41" name="CustomShape 3"/>
            <p:cNvSpPr/>
            <p:nvPr/>
          </p:nvSpPr>
          <p:spPr>
            <a:xfrm>
              <a:off x="4078800" y="2624400"/>
              <a:ext cx="71280" cy="86328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2" name="CustomShape 4"/>
            <p:cNvSpPr/>
            <p:nvPr/>
          </p:nvSpPr>
          <p:spPr>
            <a:xfrm>
              <a:off x="6094800" y="2624400"/>
              <a:ext cx="71280" cy="86328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3" name="CustomShape 5"/>
            <p:cNvSpPr/>
            <p:nvPr/>
          </p:nvSpPr>
          <p:spPr>
            <a:xfrm>
              <a:off x="1918800" y="3533040"/>
              <a:ext cx="71280" cy="54900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4" name="CustomShape 6"/>
            <p:cNvSpPr/>
            <p:nvPr/>
          </p:nvSpPr>
          <p:spPr>
            <a:xfrm>
              <a:off x="3880080" y="4453200"/>
              <a:ext cx="71280" cy="86328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5" name="CustomShape 7"/>
            <p:cNvSpPr/>
            <p:nvPr/>
          </p:nvSpPr>
          <p:spPr>
            <a:xfrm>
              <a:off x="5256720" y="4453200"/>
              <a:ext cx="71280" cy="8244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6" name="CustomShape 8"/>
            <p:cNvSpPr/>
            <p:nvPr/>
          </p:nvSpPr>
          <p:spPr>
            <a:xfrm>
              <a:off x="3587760" y="5376240"/>
              <a:ext cx="71280" cy="52740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7" name="CustomShape 9"/>
            <p:cNvSpPr/>
            <p:nvPr/>
          </p:nvSpPr>
          <p:spPr>
            <a:xfrm>
              <a:off x="4170960" y="445320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8" name="CustomShape 10"/>
            <p:cNvSpPr/>
            <p:nvPr/>
          </p:nvSpPr>
          <p:spPr>
            <a:xfrm>
              <a:off x="4368240" y="445320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49" name="CustomShape 11"/>
            <p:cNvSpPr/>
            <p:nvPr/>
          </p:nvSpPr>
          <p:spPr>
            <a:xfrm>
              <a:off x="6091920" y="353880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0" name="CustomShape 12"/>
            <p:cNvSpPr/>
            <p:nvPr/>
          </p:nvSpPr>
          <p:spPr>
            <a:xfrm>
              <a:off x="5988240" y="353880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1" name="CustomShape 13"/>
            <p:cNvSpPr/>
            <p:nvPr/>
          </p:nvSpPr>
          <p:spPr>
            <a:xfrm>
              <a:off x="6091920" y="4457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2" name="CustomShape 14"/>
            <p:cNvSpPr/>
            <p:nvPr/>
          </p:nvSpPr>
          <p:spPr>
            <a:xfrm>
              <a:off x="6140880" y="4457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3" name="CustomShape 15"/>
            <p:cNvSpPr/>
            <p:nvPr/>
          </p:nvSpPr>
          <p:spPr>
            <a:xfrm>
              <a:off x="5844240" y="4457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4" name="CustomShape 16"/>
            <p:cNvSpPr/>
            <p:nvPr/>
          </p:nvSpPr>
          <p:spPr>
            <a:xfrm>
              <a:off x="5988240" y="4457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5" name="CustomShape 17"/>
            <p:cNvSpPr/>
            <p:nvPr/>
          </p:nvSpPr>
          <p:spPr>
            <a:xfrm>
              <a:off x="4179600" y="2621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6" name="CustomShape 18"/>
            <p:cNvSpPr/>
            <p:nvPr/>
          </p:nvSpPr>
          <p:spPr>
            <a:xfrm>
              <a:off x="5209200" y="2621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7" name="CustomShape 19"/>
            <p:cNvSpPr/>
            <p:nvPr/>
          </p:nvSpPr>
          <p:spPr>
            <a:xfrm>
              <a:off x="5403600" y="2621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8" name="CustomShape 20"/>
            <p:cNvSpPr/>
            <p:nvPr/>
          </p:nvSpPr>
          <p:spPr>
            <a:xfrm>
              <a:off x="5844240" y="262152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59" name="CustomShape 21"/>
            <p:cNvSpPr/>
            <p:nvPr/>
          </p:nvSpPr>
          <p:spPr>
            <a:xfrm>
              <a:off x="2064240" y="353880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60" name="CustomShape 22"/>
            <p:cNvSpPr/>
            <p:nvPr/>
          </p:nvSpPr>
          <p:spPr>
            <a:xfrm>
              <a:off x="2411280" y="3538800"/>
              <a:ext cx="71280" cy="863280"/>
            </a:xfrm>
            <a:prstGeom prst="rect">
              <a:avLst/>
            </a:prstGeom>
            <a:solidFill>
              <a:srgbClr val="8000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61" name="CustomShape 23"/>
            <p:cNvSpPr/>
            <p:nvPr/>
          </p:nvSpPr>
          <p:spPr>
            <a:xfrm>
              <a:off x="5256720" y="4587120"/>
              <a:ext cx="71280" cy="13716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62" name="CustomShape 24"/>
            <p:cNvSpPr/>
            <p:nvPr/>
          </p:nvSpPr>
          <p:spPr>
            <a:xfrm>
              <a:off x="5256720" y="4786920"/>
              <a:ext cx="71280" cy="53424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63" name="CustomShape 25"/>
            <p:cNvSpPr/>
            <p:nvPr/>
          </p:nvSpPr>
          <p:spPr>
            <a:xfrm>
              <a:off x="3587760" y="5958720"/>
              <a:ext cx="71280" cy="279000"/>
            </a:xfrm>
            <a:prstGeom prst="rect">
              <a:avLst/>
            </a:prstGeom>
            <a:solidFill>
              <a:srgbClr val="ffff00">
                <a:alpha val="50000"/>
              </a:srgbClr>
            </a:solidFill>
            <a:ln>
              <a:solidFill>
                <a:srgbClr val="3465a4"/>
              </a:solidFill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64" name="Line 26"/>
            <p:cNvSpPr/>
            <p:nvPr/>
          </p:nvSpPr>
          <p:spPr>
            <a:xfrm flipV="1">
              <a:off x="3623760" y="6264000"/>
              <a:ext cx="360" cy="144000"/>
            </a:xfrm>
            <a:prstGeom prst="line">
              <a:avLst/>
            </a:prstGeom>
            <a:ln>
              <a:solidFill>
                <a:srgbClr val="000000"/>
              </a:solidFill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</p:sp>
        <p:sp>
          <p:nvSpPr>
            <p:cNvPr id="65" name="CustomShape 27"/>
            <p:cNvSpPr/>
            <p:nvPr/>
          </p:nvSpPr>
          <p:spPr>
            <a:xfrm>
              <a:off x="3297240" y="6435000"/>
              <a:ext cx="610200" cy="2318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0" lang="fr-FR" sz="1000" spc="-1" strike="noStrike">
                  <a:latin typeface="Arial"/>
                </a:rPr>
                <a:t>Cys363</a:t>
              </a:r>
              <a:endParaRPr b="0" lang="fr-FR" sz="1000" spc="-1" strike="noStrike">
                <a:latin typeface="Arial"/>
              </a:endParaRPr>
            </a:p>
          </p:txBody>
        </p:sp>
      </p:grp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9</TotalTime>
  <Application>LibreOffice/6.0.6.2$Linux_X86_64 LibreOffice_project/00m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0T12:55:51Z</dcterms:created>
  <dc:creator>JP </dc:creator>
  <dc:description/>
  <dc:language>fr-FR</dc:language>
  <cp:lastModifiedBy>JP </cp:lastModifiedBy>
  <cp:lastPrinted>2018-10-04T14:41:22Z</cp:lastPrinted>
  <dcterms:modified xsi:type="dcterms:W3CDTF">2018-12-06T09:50:05Z</dcterms:modified>
  <cp:revision>30</cp:revision>
  <dc:subject/>
  <dc:title/>
</cp:coreProperties>
</file>